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A8C2D1-647B-4219-8E5B-77C18BC644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0716CA-72F6-427C-843C-9B7B92DC9C7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67B999-CE09-473A-A09B-B3027C86EB6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7D07A9-2318-40AD-82FA-1AEDA465AC3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7552E5-C76C-4B9B-A401-4169570FDE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98E07E-48E8-4884-BF99-5BC307045DB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6BF18F-01A1-461D-9F2E-3D9FE3A7E51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D09E7A-6C1E-431A-90E5-57581D71209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F7D6E8-3FCF-4882-9729-4D1E56B57E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4D8C1B-B436-4910-9057-04D3BC8F3D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3175E2-F064-4026-8C55-0EDD85215A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F2B37-6C22-4EA1-B322-EE6504AD35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70CA39AB-5FE5-4D2C-A14D-DFCCF5AF070C}" type="datetime">
              <a:rPr b="0" lang="fr-FR" sz="1200" spc="-1" strike="noStrike">
                <a:solidFill>
                  <a:srgbClr val="898989"/>
                </a:solidFill>
                <a:latin typeface="Calibri"/>
              </a:rPr>
              <a:t>29/08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85D34A7-31AE-4E1D-A5B8-A99716D47538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r 193"/>
          <p:cNvGrpSpPr/>
          <p:nvPr/>
        </p:nvGrpSpPr>
        <p:grpSpPr>
          <a:xfrm>
            <a:off x="1773360" y="2638440"/>
            <a:ext cx="2133360" cy="774720"/>
            <a:chOff x="1773360" y="2638440"/>
            <a:chExt cx="2133360" cy="774720"/>
          </a:xfrm>
        </p:grpSpPr>
        <p:sp>
          <p:nvSpPr>
            <p:cNvPr id="42" name="ZoneTexte 186"/>
            <p:cNvSpPr/>
            <p:nvPr/>
          </p:nvSpPr>
          <p:spPr>
            <a:xfrm>
              <a:off x="1773360" y="308628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Calibri"/>
                </a:rPr>
                <a:t>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ZoneTexte 189"/>
            <p:cNvSpPr/>
            <p:nvPr/>
          </p:nvSpPr>
          <p:spPr>
            <a:xfrm>
              <a:off x="1782720" y="2638440"/>
              <a:ext cx="426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Akt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44" name="Image 192" descr="actin article.jpg"/>
            <p:cNvPicPr/>
            <p:nvPr/>
          </p:nvPicPr>
          <p:blipFill>
            <a:blip r:embed="rId1"/>
            <a:stretch/>
          </p:blipFill>
          <p:spPr>
            <a:xfrm>
              <a:off x="2306520" y="3044880"/>
              <a:ext cx="1600200" cy="368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Image 194" descr="AKT  article.jpg"/>
            <p:cNvPicPr/>
            <p:nvPr/>
          </p:nvPicPr>
          <p:blipFill>
            <a:blip r:embed="rId2"/>
            <a:stretch/>
          </p:blipFill>
          <p:spPr>
            <a:xfrm>
              <a:off x="2306520" y="2638440"/>
              <a:ext cx="1600200" cy="3556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6" name="ZoneTexte 12"/>
          <p:cNvSpPr/>
          <p:nvPr/>
        </p:nvSpPr>
        <p:spPr>
          <a:xfrm>
            <a:off x="1576440" y="1955880"/>
            <a:ext cx="582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File 1: Knock-down of the Akt signal by shAk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ZoneTexte 13"/>
          <p:cNvSpPr/>
          <p:nvPr/>
        </p:nvSpPr>
        <p:spPr>
          <a:xfrm>
            <a:off x="1422720" y="3475080"/>
            <a:ext cx="2446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Sh control         -            +          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14"/>
          <p:cNvSpPr/>
          <p:nvPr/>
        </p:nvSpPr>
        <p:spPr>
          <a:xfrm>
            <a:off x="1371600" y="3736800"/>
            <a:ext cx="289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Arial"/>
                <a:ea typeface="Arial"/>
              </a:rPr>
              <a:t>Sh Akt(1+2)       -             -          +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Rectangle 10"/>
          <p:cNvSpPr/>
          <p:nvPr/>
        </p:nvSpPr>
        <p:spPr>
          <a:xfrm>
            <a:off x="4265640" y="2655720"/>
            <a:ext cx="457200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</a:rPr>
              <a:t>Transfections were carried out by the Icafectin method (Eurogentec ) accordind to the manufacturer’ protocol  with the shRNA  as indicated. The cells were serum-starved during 48h and then harvested and analyzed by Western blotting with the Akt antibody. Actin was used as 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3T18:50:26Z</dcterms:created>
  <dc:creator>Anne-Marie</dc:creator>
  <dc:description/>
  <dc:language>en-US</dc:language>
  <cp:lastModifiedBy>Anne-Marie</cp:lastModifiedBy>
  <dcterms:modified xsi:type="dcterms:W3CDTF">2012-07-05T14:44:09Z</dcterms:modified>
  <cp:revision>10</cp:revision>
  <dc:subject/>
  <dc:title>Diapositive 1</dc:title>
</cp:coreProperties>
</file>